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9" r:id="rId2"/>
  </p:sldIdLst>
  <p:sldSz cx="6858000" cy="9144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92" userDrawn="1">
          <p15:clr>
            <a:srgbClr val="A4A3A4"/>
          </p15:clr>
        </p15:guide>
        <p15:guide id="2" pos="28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517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1932" y="72"/>
      </p:cViewPr>
      <p:guideLst>
        <p:guide orient="horz" pos="1292"/>
        <p:guide pos="288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2_&#30740;&#31350;&#30330;&#34920;\01_&#35542;&#25991;\Male%20sterility%20is%20determained%20by%20MS-P1\05_Frontier_in_Plant_Science_Revies&#23550;&#24540;\&#20877;&#12293;&#25237;&#31295;\qRT-PCR&#12487;&#12540;&#12479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2_&#30740;&#31350;&#30330;&#34920;\01_&#35542;&#25991;\Male%20sterility%20is%20determained%20by%20MS-P1\05_Frontier_in_Plant_Science_Revies&#23550;&#24540;\&#20877;&#12293;&#25237;&#31295;\qRT-PCR&#12487;&#12540;&#12479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2_&#30740;&#31350;&#30330;&#34920;\01_&#35542;&#25991;\Male%20sterility%20is%20determained%20by%20MS-P1\05_Frontier_in_Plant_Science_Revies&#23550;&#24540;\&#20877;&#12293;&#25237;&#31295;\qRT-PCR&#12487;&#12540;&#1247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 b="0" i="0" baseline="0" dirty="0">
                <a:effectLst/>
              </a:rPr>
              <a:t>Ciclev10030361m</a:t>
            </a:r>
            <a:endParaRPr lang="ja-JP" altLang="ja-JP" sz="1200" dirty="0">
              <a:effectLst/>
            </a:endParaRPr>
          </a:p>
        </c:rich>
      </c:tx>
      <c:layout>
        <c:manualLayout>
          <c:xMode val="edge"/>
          <c:yMode val="edge"/>
          <c:x val="0.19044420498084291"/>
          <c:y val="0.1080781893004115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5E2-4A8D-ADE6-A3021D712594}"/>
              </c:ext>
            </c:extLst>
          </c:dPt>
          <c:dPt>
            <c:idx val="1"/>
            <c:invertIfNegative val="0"/>
            <c:bubble3D val="0"/>
            <c:spPr>
              <a:solidFill>
                <a:srgbClr val="BFBFBF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65E2-4A8D-ADE6-A3021D71259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5E2-4A8D-ADE6-A3021D712594}"/>
              </c:ext>
            </c:extLst>
          </c:dPt>
          <c:dPt>
            <c:idx val="3"/>
            <c:invertIfNegative val="0"/>
            <c:bubble3D val="0"/>
            <c:spPr>
              <a:solidFill>
                <a:srgbClr val="BFBFBF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6-65E2-4A8D-ADE6-A3021D712594}"/>
              </c:ext>
            </c:extLst>
          </c:dPt>
          <c:errBars>
            <c:errBarType val="both"/>
            <c:errValType val="cust"/>
            <c:noEndCap val="0"/>
            <c:plus>
              <c:numRef>
                <c:f>Ciclev10030242_Ciclev10030361!$J$28:$J$31</c:f>
                <c:numCache>
                  <c:formatCode>General</c:formatCode>
                  <c:ptCount val="4"/>
                  <c:pt idx="0">
                    <c:v>0.15169416481174844</c:v>
                  </c:pt>
                  <c:pt idx="1">
                    <c:v>0.12373187262597975</c:v>
                  </c:pt>
                  <c:pt idx="2">
                    <c:v>0.1137563646131383</c:v>
                  </c:pt>
                  <c:pt idx="3">
                    <c:v>9.6436923637539904E-2</c:v>
                  </c:pt>
                </c:numCache>
              </c:numRef>
            </c:plus>
            <c:minus>
              <c:numRef>
                <c:f>Ciclev10030242_Ciclev10030361!$J$28:$J$31</c:f>
                <c:numCache>
                  <c:formatCode>General</c:formatCode>
                  <c:ptCount val="4"/>
                  <c:pt idx="0">
                    <c:v>0.15169416481174844</c:v>
                  </c:pt>
                  <c:pt idx="1">
                    <c:v>0.12373187262597975</c:v>
                  </c:pt>
                  <c:pt idx="2">
                    <c:v>0.1137563646131383</c:v>
                  </c:pt>
                  <c:pt idx="3">
                    <c:v>9.6436923637539904E-2</c:v>
                  </c:pt>
                </c:numCache>
              </c:numRef>
            </c:minus>
            <c:spPr>
              <a:ln w="9525"/>
            </c:spPr>
          </c:errBars>
          <c:cat>
            <c:strRef>
              <c:f>Ciclev10030242_Ciclev10030361!$D$28:$D$31</c:f>
              <c:strCache>
                <c:ptCount val="4"/>
                <c:pt idx="0">
                  <c:v>7 DBF</c:v>
                </c:pt>
                <c:pt idx="1">
                  <c:v>7 DBF</c:v>
                </c:pt>
                <c:pt idx="2">
                  <c:v>1 DBF</c:v>
                </c:pt>
                <c:pt idx="3">
                  <c:v>1 DBF</c:v>
                </c:pt>
              </c:strCache>
            </c:strRef>
          </c:cat>
          <c:val>
            <c:numRef>
              <c:f>Ciclev10030242_Ciclev10030361!$I$28:$I$31</c:f>
              <c:numCache>
                <c:formatCode>#,##0.000000</c:formatCode>
                <c:ptCount val="4"/>
                <c:pt idx="0">
                  <c:v>1</c:v>
                </c:pt>
                <c:pt idx="1">
                  <c:v>3.5677917340199428</c:v>
                </c:pt>
                <c:pt idx="2">
                  <c:v>1.0206406622854571</c:v>
                </c:pt>
                <c:pt idx="3">
                  <c:v>3.67387170135745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5E2-4A8D-ADE6-A3021D7125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66152480"/>
        <c:axId val="566160024"/>
      </c:barChart>
      <c:catAx>
        <c:axId val="5661524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66160024"/>
        <c:crosses val="autoZero"/>
        <c:auto val="1"/>
        <c:lblAlgn val="ctr"/>
        <c:lblOffset val="100"/>
        <c:noMultiLvlLbl val="0"/>
      </c:catAx>
      <c:valAx>
        <c:axId val="566160024"/>
        <c:scaling>
          <c:orientation val="minMax"/>
          <c:max val="12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952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6615248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  <c:extLst/>
  </c:chart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 b="0" i="0" baseline="0" dirty="0">
                <a:effectLst/>
              </a:rPr>
              <a:t>Ciclev10030242m</a:t>
            </a:r>
            <a:endParaRPr lang="ja-JP" altLang="ja-JP" sz="1200" dirty="0">
              <a:effectLst/>
            </a:endParaRPr>
          </a:p>
        </c:rich>
      </c:tx>
      <c:layout>
        <c:manualLayout>
          <c:xMode val="edge"/>
          <c:yMode val="edge"/>
          <c:x val="0.19408328261359226"/>
          <c:y val="0.10807767489711935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EED-4B4D-B499-91D71B03336B}"/>
              </c:ext>
            </c:extLst>
          </c:dPt>
          <c:dPt>
            <c:idx val="1"/>
            <c:invertIfNegative val="0"/>
            <c:bubble3D val="0"/>
            <c:spPr>
              <a:solidFill>
                <a:srgbClr val="BFBFB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EED-4B4D-B499-91D71B03336B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EED-4B4D-B499-91D71B03336B}"/>
              </c:ext>
            </c:extLst>
          </c:dPt>
          <c:dPt>
            <c:idx val="3"/>
            <c:invertIfNegative val="0"/>
            <c:bubble3D val="0"/>
            <c:spPr>
              <a:solidFill>
                <a:srgbClr val="BFBFB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3EED-4B4D-B499-91D71B03336B}"/>
              </c:ext>
            </c:extLst>
          </c:dPt>
          <c:errBars>
            <c:errBarType val="both"/>
            <c:errValType val="cust"/>
            <c:noEndCap val="0"/>
            <c:plus>
              <c:numRef>
                <c:f>Ciclev10030242!$J$11:$J$14</c:f>
                <c:numCache>
                  <c:formatCode>General</c:formatCode>
                  <c:ptCount val="4"/>
                  <c:pt idx="0">
                    <c:v>0.23883818742155216</c:v>
                  </c:pt>
                  <c:pt idx="1">
                    <c:v>0.33701742225144482</c:v>
                  </c:pt>
                  <c:pt idx="2">
                    <c:v>0.10658760170539536</c:v>
                  </c:pt>
                  <c:pt idx="3">
                    <c:v>0.40313780372560959</c:v>
                  </c:pt>
                </c:numCache>
              </c:numRef>
            </c:plus>
            <c:minus>
              <c:numRef>
                <c:f>Ciclev10030242!$J$11:$J$14</c:f>
                <c:numCache>
                  <c:formatCode>General</c:formatCode>
                  <c:ptCount val="4"/>
                  <c:pt idx="0">
                    <c:v>0.23883818742155216</c:v>
                  </c:pt>
                  <c:pt idx="1">
                    <c:v>0.33701742225144482</c:v>
                  </c:pt>
                  <c:pt idx="2">
                    <c:v>0.10658760170539536</c:v>
                  </c:pt>
                  <c:pt idx="3">
                    <c:v>0.40313780372560959</c:v>
                  </c:pt>
                </c:numCache>
              </c:numRef>
            </c:minus>
            <c:spPr>
              <a:ln w="9525"/>
            </c:spPr>
          </c:errBars>
          <c:cat>
            <c:strRef>
              <c:f>Ciclev10030242!$D$11:$D$14</c:f>
              <c:strCache>
                <c:ptCount val="4"/>
                <c:pt idx="0">
                  <c:v>7 DBF</c:v>
                </c:pt>
                <c:pt idx="1">
                  <c:v>7 DBF</c:v>
                </c:pt>
                <c:pt idx="2">
                  <c:v>1 DBF</c:v>
                </c:pt>
                <c:pt idx="3">
                  <c:v>1 DBF</c:v>
                </c:pt>
              </c:strCache>
            </c:strRef>
          </c:cat>
          <c:val>
            <c:numRef>
              <c:f>Ciclev10030242!$I$11:$I$14</c:f>
              <c:numCache>
                <c:formatCode>#,##0.000000</c:formatCode>
                <c:ptCount val="4"/>
                <c:pt idx="0">
                  <c:v>1</c:v>
                </c:pt>
                <c:pt idx="1">
                  <c:v>10.537859482868887</c:v>
                </c:pt>
                <c:pt idx="2">
                  <c:v>0.74850668206118609</c:v>
                </c:pt>
                <c:pt idx="3">
                  <c:v>5.41338825621080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EED-4B4D-B499-91D71B0333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66152480"/>
        <c:axId val="566160024"/>
      </c:barChart>
      <c:catAx>
        <c:axId val="5661524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66160024"/>
        <c:crosses val="autoZero"/>
        <c:auto val="1"/>
        <c:lblAlgn val="ctr"/>
        <c:lblOffset val="100"/>
        <c:noMultiLvlLbl val="0"/>
      </c:catAx>
      <c:valAx>
        <c:axId val="566160024"/>
        <c:scaling>
          <c:orientation val="minMax"/>
          <c:max val="12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952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6615248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  <c:extLst/>
  </c:chart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 b="0" i="0" baseline="0" dirty="0">
                <a:effectLst/>
              </a:rPr>
              <a:t>Ciclev10029947m</a:t>
            </a:r>
            <a:endParaRPr lang="ja-JP" altLang="ja-JP" sz="800" dirty="0">
              <a:effectLst/>
            </a:endParaRPr>
          </a:p>
        </c:rich>
      </c:tx>
      <c:layout>
        <c:manualLayout>
          <c:xMode val="edge"/>
          <c:yMode val="edge"/>
          <c:x val="0.19044437103486406"/>
          <c:y val="0.12114385584928723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fixedVal"/>
            <c:noEndCap val="0"/>
            <c:val val="0"/>
          </c:errBars>
          <c:cat>
            <c:strRef>
              <c:f>Ciclev10030242_Ciclev10030361!$D$35:$D$38</c:f>
              <c:strCache>
                <c:ptCount val="4"/>
                <c:pt idx="0">
                  <c:v>7 DBF</c:v>
                </c:pt>
                <c:pt idx="1">
                  <c:v>7 DBF</c:v>
                </c:pt>
                <c:pt idx="2">
                  <c:v>1 DBF</c:v>
                </c:pt>
                <c:pt idx="3">
                  <c:v>1 DBF</c:v>
                </c:pt>
              </c:strCache>
            </c:strRef>
          </c:cat>
          <c:val>
            <c:numRef>
              <c:f>Ciclev10030242_Ciclev10030361!$I$35:$I$38</c:f>
              <c:numCache>
                <c:formatCode>#,##0.000000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87-4CF1-9A40-E0FE13CB58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66152480"/>
        <c:axId val="566160024"/>
      </c:barChart>
      <c:catAx>
        <c:axId val="5661524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66160024"/>
        <c:crosses val="autoZero"/>
        <c:auto val="1"/>
        <c:lblAlgn val="ctr"/>
        <c:lblOffset val="100"/>
        <c:noMultiLvlLbl val="0"/>
      </c:catAx>
      <c:valAx>
        <c:axId val="566160024"/>
        <c:scaling>
          <c:orientation val="minMax"/>
          <c:max val="12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952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6615248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  <c:extLst/>
  </c:chart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7853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428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8116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3978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4675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45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667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930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9769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0290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6567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EDD2C2-18EF-4734-92B6-A9BE04A8075E}" type="datetimeFigureOut">
              <a:rPr kumimoji="1" lang="ja-JP" altLang="en-US" smtClean="0"/>
              <a:t>2023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F323BD-868A-448C-95D7-4F092B1D5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0935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5" Type="http://schemas.openxmlformats.org/officeDocument/2006/relationships/image" Target="../media/image2.jpeg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BC240738-9457-4A06-8A7F-309CC5FC3B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7255703"/>
              </p:ext>
            </p:extLst>
          </p:nvPr>
        </p:nvGraphicFramePr>
        <p:xfrm>
          <a:off x="1889772" y="216163"/>
          <a:ext cx="1670400" cy="194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A20F09B8-3C74-F820-E788-E2940F9D13C0}"/>
              </a:ext>
            </a:extLst>
          </p:cNvPr>
          <p:cNvSpPr txBox="1"/>
          <p:nvPr/>
        </p:nvSpPr>
        <p:spPr>
          <a:xfrm>
            <a:off x="32753" y="28261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4EB0D1CA-96D0-6646-2D4D-B39996EAC72C}"/>
              </a:ext>
            </a:extLst>
          </p:cNvPr>
          <p:cNvSpPr txBox="1"/>
          <p:nvPr/>
        </p:nvSpPr>
        <p:spPr>
          <a:xfrm>
            <a:off x="30183" y="4650096"/>
            <a:ext cx="679132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Expression of PPR family genes predicted to be localized in the mitochondria at the 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-P1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 evaluated using RT-PCR</a:t>
            </a:r>
          </a:p>
          <a:p>
            <a:pPr>
              <a:buAutoNum type="alphaUcParenBoth"/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of Ciclev10030242m, </a:t>
            </a:r>
            <a:r>
              <a:rPr lang="en-US" altLang="ja-JP" sz="1200" b="0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iclev10030361m, and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clev10029947</a:t>
            </a:r>
            <a:r>
              <a:rPr kumimoji="1" lang="en-US" altLang="ja-JP" sz="1200" b="0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KyOw14 and ‘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ranuh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t 7 and 1 DBF evaluated using quantitative RT-PCR. RNA-seq analysis detected the reads of Ciclev10030242m and </a:t>
            </a:r>
            <a:r>
              <a:rPr lang="en-US" altLang="ja-JP" sz="1200" b="0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iclev10030361m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KyOw14 and ‘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ranuh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</a:t>
            </a:r>
            <a:r>
              <a:rPr lang="en-US" altLang="ja-JP" sz="1200" b="0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y RNA-seq, but barely detected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clev10029947 </a:t>
            </a:r>
            <a:r>
              <a:rPr lang="en-US" altLang="ja-JP" sz="1200" b="0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Table S5)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White and gray bars indicate gene expressions in KyOw14 and ‘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ranuh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, respectively. Average gene expression of three replicates are shown relative ratio to that of KyOw14 at 7 DBF with SD. N.D shows PCR amplification was not detected. Asterisks indicate significant differences according to the t-test (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). (B) Gene expression of Ciclev10029947m in KyOw14 and ‘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ranuh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t 7 and 1 DBF evaluated using semi-quantitative RT-PCR. Primer pairs of Ciclev10029947m and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EF1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used same as in Fig. S3A. Genomic DNA was used as a positive control.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EF1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indicated as an internal control.</a:t>
            </a:r>
          </a:p>
        </p:txBody>
      </p:sp>
      <p:grpSp>
        <p:nvGrpSpPr>
          <p:cNvPr id="166" name="グループ化 165">
            <a:extLst>
              <a:ext uri="{FF2B5EF4-FFF2-40B4-BE49-F238E27FC236}">
                <a16:creationId xmlns:a16="http://schemas.microsoft.com/office/drawing/2014/main" id="{B79EAF93-5312-CA01-A8D6-9F64774526AF}"/>
              </a:ext>
            </a:extLst>
          </p:cNvPr>
          <p:cNvGrpSpPr/>
          <p:nvPr/>
        </p:nvGrpSpPr>
        <p:grpSpPr>
          <a:xfrm>
            <a:off x="156203" y="215942"/>
            <a:ext cx="5050296" cy="2264657"/>
            <a:chOff x="537514" y="342900"/>
            <a:chExt cx="5050296" cy="2264657"/>
          </a:xfrm>
        </p:grpSpPr>
        <p:graphicFrame>
          <p:nvGraphicFramePr>
            <p:cNvPr id="2" name="グラフ 1">
              <a:extLst>
                <a:ext uri="{FF2B5EF4-FFF2-40B4-BE49-F238E27FC236}">
                  <a16:creationId xmlns:a16="http://schemas.microsoft.com/office/drawing/2014/main" id="{41A4E07D-B50A-4E66-B9EC-DA0F9E6BFFA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19109012"/>
                </p:ext>
              </p:extLst>
            </p:nvPr>
          </p:nvGraphicFramePr>
          <p:xfrm>
            <a:off x="673455" y="342900"/>
            <a:ext cx="1669304" cy="194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0541C0A1-B641-D18B-130C-54AD9134AE5A}"/>
                </a:ext>
              </a:extLst>
            </p:cNvPr>
            <p:cNvSpPr txBox="1"/>
            <p:nvPr/>
          </p:nvSpPr>
          <p:spPr>
            <a:xfrm rot="16200000">
              <a:off x="-45178" y="1274443"/>
              <a:ext cx="14269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expression level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5" name="グループ化 224">
              <a:extLst>
                <a:ext uri="{FF2B5EF4-FFF2-40B4-BE49-F238E27FC236}">
                  <a16:creationId xmlns:a16="http://schemas.microsoft.com/office/drawing/2014/main" id="{5E4F45F8-EE33-F085-AB30-E086DFCA103A}"/>
                </a:ext>
              </a:extLst>
            </p:cNvPr>
            <p:cNvGrpSpPr/>
            <p:nvPr/>
          </p:nvGrpSpPr>
          <p:grpSpPr>
            <a:xfrm>
              <a:off x="4025129" y="2345947"/>
              <a:ext cx="1562681" cy="261610"/>
              <a:chOff x="2261920" y="114897"/>
              <a:chExt cx="1562681" cy="261610"/>
            </a:xfrm>
          </p:grpSpPr>
          <p:sp>
            <p:nvSpPr>
              <p:cNvPr id="226" name="正方形/長方形 225">
                <a:extLst>
                  <a:ext uri="{FF2B5EF4-FFF2-40B4-BE49-F238E27FC236}">
                    <a16:creationId xmlns:a16="http://schemas.microsoft.com/office/drawing/2014/main" id="{19080BFD-8DCD-B403-1C36-1E41D3C086C1}"/>
                  </a:ext>
                </a:extLst>
              </p:cNvPr>
              <p:cNvSpPr/>
              <p:nvPr/>
            </p:nvSpPr>
            <p:spPr>
              <a:xfrm>
                <a:off x="2261920" y="171019"/>
                <a:ext cx="108000" cy="11858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229" name="正方形/長方形 228">
                <a:extLst>
                  <a:ext uri="{FF2B5EF4-FFF2-40B4-BE49-F238E27FC236}">
                    <a16:creationId xmlns:a16="http://schemas.microsoft.com/office/drawing/2014/main" id="{1E5958BD-6D3F-706B-0C0C-2E8D59291856}"/>
                  </a:ext>
                </a:extLst>
              </p:cNvPr>
              <p:cNvSpPr/>
              <p:nvPr/>
            </p:nvSpPr>
            <p:spPr>
              <a:xfrm>
                <a:off x="3030345" y="171019"/>
                <a:ext cx="108000" cy="118588"/>
              </a:xfrm>
              <a:prstGeom prst="rect">
                <a:avLst/>
              </a:prstGeom>
              <a:solidFill>
                <a:srgbClr val="BFBFB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243" name="テキスト ボックス 242">
                <a:extLst>
                  <a:ext uri="{FF2B5EF4-FFF2-40B4-BE49-F238E27FC236}">
                    <a16:creationId xmlns:a16="http://schemas.microsoft.com/office/drawing/2014/main" id="{A4674088-2BE5-9CCA-D0F5-61BBD54959E6}"/>
                  </a:ext>
                </a:extLst>
              </p:cNvPr>
              <p:cNvSpPr txBox="1"/>
              <p:nvPr/>
            </p:nvSpPr>
            <p:spPr>
              <a:xfrm>
                <a:off x="2312800" y="114897"/>
                <a:ext cx="70403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yOw14</a:t>
                </a:r>
                <a:endParaRPr kumimoji="1" lang="ja-JP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0F7DF783-AFBE-20AB-EE60-AAD97343F63E}"/>
                  </a:ext>
                </a:extLst>
              </p:cNvPr>
              <p:cNvSpPr txBox="1"/>
              <p:nvPr/>
            </p:nvSpPr>
            <p:spPr>
              <a:xfrm>
                <a:off x="3093311" y="114897"/>
                <a:ext cx="73129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iranuhi</a:t>
                </a:r>
                <a:endParaRPr kumimoji="1" lang="ja-JP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55" name="グループ化 254">
              <a:extLst>
                <a:ext uri="{FF2B5EF4-FFF2-40B4-BE49-F238E27FC236}">
                  <a16:creationId xmlns:a16="http://schemas.microsoft.com/office/drawing/2014/main" id="{E8388F88-6E01-5BD7-EC50-46DF2FC8EBDE}"/>
                </a:ext>
              </a:extLst>
            </p:cNvPr>
            <p:cNvGrpSpPr/>
            <p:nvPr/>
          </p:nvGrpSpPr>
          <p:grpSpPr>
            <a:xfrm>
              <a:off x="1038666" y="2138822"/>
              <a:ext cx="1174640" cy="261610"/>
              <a:chOff x="1038666" y="2138822"/>
              <a:chExt cx="1174640" cy="261610"/>
            </a:xfrm>
          </p:grpSpPr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6BF8B16D-3C44-8E24-6B65-6A9E252BBAD8}"/>
                  </a:ext>
                </a:extLst>
              </p:cNvPr>
              <p:cNvGrpSpPr/>
              <p:nvPr/>
            </p:nvGrpSpPr>
            <p:grpSpPr>
              <a:xfrm>
                <a:off x="1038666" y="2138822"/>
                <a:ext cx="1174640" cy="261610"/>
                <a:chOff x="626258" y="3314950"/>
                <a:chExt cx="1174640" cy="261610"/>
              </a:xfrm>
            </p:grpSpPr>
            <p:grpSp>
              <p:nvGrpSpPr>
                <p:cNvPr id="6" name="グループ化 5">
                  <a:extLst>
                    <a:ext uri="{FF2B5EF4-FFF2-40B4-BE49-F238E27FC236}">
                      <a16:creationId xmlns:a16="http://schemas.microsoft.com/office/drawing/2014/main" id="{B9F2BC6C-8CBE-3124-4C21-6DB3DC56A752}"/>
                    </a:ext>
                  </a:extLst>
                </p:cNvPr>
                <p:cNvGrpSpPr/>
                <p:nvPr/>
              </p:nvGrpSpPr>
              <p:grpSpPr>
                <a:xfrm>
                  <a:off x="626258" y="3314950"/>
                  <a:ext cx="566181" cy="261610"/>
                  <a:chOff x="626258" y="3314950"/>
                  <a:chExt cx="566181" cy="261610"/>
                </a:xfrm>
              </p:grpSpPr>
              <p:cxnSp>
                <p:nvCxnSpPr>
                  <p:cNvPr id="10" name="直線コネクタ 9">
                    <a:extLst>
                      <a:ext uri="{FF2B5EF4-FFF2-40B4-BE49-F238E27FC236}">
                        <a16:creationId xmlns:a16="http://schemas.microsoft.com/office/drawing/2014/main" id="{D1B59576-C1E4-762E-E9BF-C254EBB8B7F8}"/>
                      </a:ext>
                    </a:extLst>
                  </p:cNvPr>
                  <p:cNvCxnSpPr/>
                  <p:nvPr/>
                </p:nvCxnSpPr>
                <p:spPr>
                  <a:xfrm>
                    <a:off x="657349" y="3358977"/>
                    <a:ext cx="504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" name="テキスト ボックス 10">
                    <a:extLst>
                      <a:ext uri="{FF2B5EF4-FFF2-40B4-BE49-F238E27FC236}">
                        <a16:creationId xmlns:a16="http://schemas.microsoft.com/office/drawing/2014/main" id="{8F4D88FB-43DC-BB8B-6D75-F2AC5E4DAA4A}"/>
                      </a:ext>
                    </a:extLst>
                  </p:cNvPr>
                  <p:cNvSpPr txBox="1"/>
                  <p:nvPr/>
                </p:nvSpPr>
                <p:spPr>
                  <a:xfrm>
                    <a:off x="626258" y="3314950"/>
                    <a:ext cx="566181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 DBF</a:t>
                    </a:r>
                    <a:endParaRPr kumimoji="1" lang="ja-JP" alt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id="{9934F6D6-D515-4E19-635A-160E6DDD14D2}"/>
                    </a:ext>
                  </a:extLst>
                </p:cNvPr>
                <p:cNvSpPr txBox="1"/>
                <p:nvPr/>
              </p:nvSpPr>
              <p:spPr>
                <a:xfrm>
                  <a:off x="1234717" y="3314950"/>
                  <a:ext cx="56618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 DBF</a:t>
                  </a:r>
                  <a:endParaRPr kumimoji="1" lang="ja-JP" alt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249" name="直線コネクタ 248">
                <a:extLst>
                  <a:ext uri="{FF2B5EF4-FFF2-40B4-BE49-F238E27FC236}">
                    <a16:creationId xmlns:a16="http://schemas.microsoft.com/office/drawing/2014/main" id="{DF17C91A-2EC1-01CD-8296-E3DCC617C4F2}"/>
                  </a:ext>
                </a:extLst>
              </p:cNvPr>
              <p:cNvCxnSpPr/>
              <p:nvPr/>
            </p:nvCxnSpPr>
            <p:spPr>
              <a:xfrm>
                <a:off x="1653132" y="2184473"/>
                <a:ext cx="50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5EA0C3E3-AC11-A8F7-2A8D-979DF0DE6F86}"/>
                </a:ext>
              </a:extLst>
            </p:cNvPr>
            <p:cNvGrpSpPr/>
            <p:nvPr/>
          </p:nvGrpSpPr>
          <p:grpSpPr>
            <a:xfrm>
              <a:off x="2637903" y="2138822"/>
              <a:ext cx="1174640" cy="261610"/>
              <a:chOff x="1038666" y="2138822"/>
              <a:chExt cx="1174640" cy="261610"/>
            </a:xfrm>
          </p:grpSpPr>
          <p:grpSp>
            <p:nvGrpSpPr>
              <p:cNvPr id="84" name="グループ化 83">
                <a:extLst>
                  <a:ext uri="{FF2B5EF4-FFF2-40B4-BE49-F238E27FC236}">
                    <a16:creationId xmlns:a16="http://schemas.microsoft.com/office/drawing/2014/main" id="{64808502-E321-2C72-E9A1-11FEEB6D601D}"/>
                  </a:ext>
                </a:extLst>
              </p:cNvPr>
              <p:cNvGrpSpPr/>
              <p:nvPr/>
            </p:nvGrpSpPr>
            <p:grpSpPr>
              <a:xfrm>
                <a:off x="1038666" y="2138822"/>
                <a:ext cx="1174640" cy="261610"/>
                <a:chOff x="626258" y="3314950"/>
                <a:chExt cx="1174640" cy="261610"/>
              </a:xfrm>
            </p:grpSpPr>
            <p:grpSp>
              <p:nvGrpSpPr>
                <p:cNvPr id="86" name="グループ化 85">
                  <a:extLst>
                    <a:ext uri="{FF2B5EF4-FFF2-40B4-BE49-F238E27FC236}">
                      <a16:creationId xmlns:a16="http://schemas.microsoft.com/office/drawing/2014/main" id="{09B5EEC5-44CB-412A-0360-B3B2EC6FF3B3}"/>
                    </a:ext>
                  </a:extLst>
                </p:cNvPr>
                <p:cNvGrpSpPr/>
                <p:nvPr/>
              </p:nvGrpSpPr>
              <p:grpSpPr>
                <a:xfrm>
                  <a:off x="626258" y="3314950"/>
                  <a:ext cx="566181" cy="261610"/>
                  <a:chOff x="626258" y="3314950"/>
                  <a:chExt cx="566181" cy="261610"/>
                </a:xfrm>
              </p:grpSpPr>
              <p:sp>
                <p:nvSpPr>
                  <p:cNvPr id="165" name="テキスト ボックス 164">
                    <a:extLst>
                      <a:ext uri="{FF2B5EF4-FFF2-40B4-BE49-F238E27FC236}">
                        <a16:creationId xmlns:a16="http://schemas.microsoft.com/office/drawing/2014/main" id="{9F70A0D9-F826-F071-16D5-0FBD42E335E3}"/>
                      </a:ext>
                    </a:extLst>
                  </p:cNvPr>
                  <p:cNvSpPr txBox="1"/>
                  <p:nvPr/>
                </p:nvSpPr>
                <p:spPr>
                  <a:xfrm>
                    <a:off x="626258" y="3314950"/>
                    <a:ext cx="566181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 DBF</a:t>
                    </a:r>
                    <a:endParaRPr kumimoji="1" lang="ja-JP" alt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64" name="直線コネクタ 163">
                    <a:extLst>
                      <a:ext uri="{FF2B5EF4-FFF2-40B4-BE49-F238E27FC236}">
                        <a16:creationId xmlns:a16="http://schemas.microsoft.com/office/drawing/2014/main" id="{FEAC4FD7-C97D-062B-57EF-A8580FFA8115}"/>
                      </a:ext>
                    </a:extLst>
                  </p:cNvPr>
                  <p:cNvCxnSpPr/>
                  <p:nvPr/>
                </p:nvCxnSpPr>
                <p:spPr>
                  <a:xfrm>
                    <a:off x="657349" y="3358977"/>
                    <a:ext cx="504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7" name="テキスト ボックス 86">
                  <a:extLst>
                    <a:ext uri="{FF2B5EF4-FFF2-40B4-BE49-F238E27FC236}">
                      <a16:creationId xmlns:a16="http://schemas.microsoft.com/office/drawing/2014/main" id="{CEAD3D50-F140-6DFB-CB3A-A0C1D0C4D129}"/>
                    </a:ext>
                  </a:extLst>
                </p:cNvPr>
                <p:cNvSpPr txBox="1"/>
                <p:nvPr/>
              </p:nvSpPr>
              <p:spPr>
                <a:xfrm>
                  <a:off x="1234717" y="3314950"/>
                  <a:ext cx="56618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 DBF</a:t>
                  </a:r>
                  <a:endParaRPr kumimoji="1" lang="ja-JP" alt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85" name="直線コネクタ 84">
                <a:extLst>
                  <a:ext uri="{FF2B5EF4-FFF2-40B4-BE49-F238E27FC236}">
                    <a16:creationId xmlns:a16="http://schemas.microsoft.com/office/drawing/2014/main" id="{CDE7EFF4-4D5B-CDFB-FB7E-757E6FEF1BA8}"/>
                  </a:ext>
                </a:extLst>
              </p:cNvPr>
              <p:cNvCxnSpPr/>
              <p:nvPr/>
            </p:nvCxnSpPr>
            <p:spPr>
              <a:xfrm>
                <a:off x="1653132" y="2184473"/>
                <a:ext cx="50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3" name="グループ化 172">
            <a:extLst>
              <a:ext uri="{FF2B5EF4-FFF2-40B4-BE49-F238E27FC236}">
                <a16:creationId xmlns:a16="http://schemas.microsoft.com/office/drawing/2014/main" id="{09A1FA0F-1086-1E10-2DCB-16E90F3211B1}"/>
              </a:ext>
            </a:extLst>
          </p:cNvPr>
          <p:cNvGrpSpPr/>
          <p:nvPr/>
        </p:nvGrpSpPr>
        <p:grpSpPr>
          <a:xfrm>
            <a:off x="777526" y="688264"/>
            <a:ext cx="298800" cy="1152000"/>
            <a:chOff x="891826" y="688264"/>
            <a:chExt cx="298800" cy="1152000"/>
          </a:xfrm>
        </p:grpSpPr>
        <p:cxnSp>
          <p:nvCxnSpPr>
            <p:cNvPr id="168" name="直線コネクタ 167">
              <a:extLst>
                <a:ext uri="{FF2B5EF4-FFF2-40B4-BE49-F238E27FC236}">
                  <a16:creationId xmlns:a16="http://schemas.microsoft.com/office/drawing/2014/main" id="{38377CB9-2AB6-5AF6-1E23-9786CA11290E}"/>
                </a:ext>
              </a:extLst>
            </p:cNvPr>
            <p:cNvCxnSpPr>
              <a:cxnSpLocks/>
            </p:cNvCxnSpPr>
            <p:nvPr/>
          </p:nvCxnSpPr>
          <p:spPr>
            <a:xfrm>
              <a:off x="895352" y="688264"/>
              <a:ext cx="0" cy="115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直線コネクタ 168">
              <a:extLst>
                <a:ext uri="{FF2B5EF4-FFF2-40B4-BE49-F238E27FC236}">
                  <a16:creationId xmlns:a16="http://schemas.microsoft.com/office/drawing/2014/main" id="{D46F93DD-C2BA-3B14-D2EE-38411701F3CF}"/>
                </a:ext>
              </a:extLst>
            </p:cNvPr>
            <p:cNvCxnSpPr>
              <a:cxnSpLocks/>
            </p:cNvCxnSpPr>
            <p:nvPr/>
          </p:nvCxnSpPr>
          <p:spPr>
            <a:xfrm>
              <a:off x="1188245" y="688264"/>
              <a:ext cx="0" cy="54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直線コネクタ 171">
              <a:extLst>
                <a:ext uri="{FF2B5EF4-FFF2-40B4-BE49-F238E27FC236}">
                  <a16:creationId xmlns:a16="http://schemas.microsoft.com/office/drawing/2014/main" id="{CCF1F5D3-A51F-64B0-4660-8DBB277FF66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41226" y="538864"/>
              <a:ext cx="0" cy="2988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4" name="グループ化 173">
            <a:extLst>
              <a:ext uri="{FF2B5EF4-FFF2-40B4-BE49-F238E27FC236}">
                <a16:creationId xmlns:a16="http://schemas.microsoft.com/office/drawing/2014/main" id="{44ECA457-7712-D314-60B9-C837897F5105}"/>
              </a:ext>
            </a:extLst>
          </p:cNvPr>
          <p:cNvGrpSpPr/>
          <p:nvPr/>
        </p:nvGrpSpPr>
        <p:grpSpPr>
          <a:xfrm>
            <a:off x="1374242" y="1232465"/>
            <a:ext cx="298800" cy="648000"/>
            <a:chOff x="891032" y="688264"/>
            <a:chExt cx="298800" cy="648000"/>
          </a:xfrm>
        </p:grpSpPr>
        <p:cxnSp>
          <p:nvCxnSpPr>
            <p:cNvPr id="175" name="直線コネクタ 174">
              <a:extLst>
                <a:ext uri="{FF2B5EF4-FFF2-40B4-BE49-F238E27FC236}">
                  <a16:creationId xmlns:a16="http://schemas.microsoft.com/office/drawing/2014/main" id="{17E2F2AE-2487-3F15-A4B2-1DA6067EB201}"/>
                </a:ext>
              </a:extLst>
            </p:cNvPr>
            <p:cNvCxnSpPr>
              <a:cxnSpLocks/>
            </p:cNvCxnSpPr>
            <p:nvPr/>
          </p:nvCxnSpPr>
          <p:spPr>
            <a:xfrm>
              <a:off x="895352" y="688264"/>
              <a:ext cx="0" cy="648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直線コネクタ 175">
              <a:extLst>
                <a:ext uri="{FF2B5EF4-FFF2-40B4-BE49-F238E27FC236}">
                  <a16:creationId xmlns:a16="http://schemas.microsoft.com/office/drawing/2014/main" id="{6E7F4DCC-5924-DB39-B829-EE5E5D538D4A}"/>
                </a:ext>
              </a:extLst>
            </p:cNvPr>
            <p:cNvCxnSpPr>
              <a:cxnSpLocks/>
            </p:cNvCxnSpPr>
            <p:nvPr/>
          </p:nvCxnSpPr>
          <p:spPr>
            <a:xfrm>
              <a:off x="1188245" y="688264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直線コネクタ 176">
              <a:extLst>
                <a:ext uri="{FF2B5EF4-FFF2-40B4-BE49-F238E27FC236}">
                  <a16:creationId xmlns:a16="http://schemas.microsoft.com/office/drawing/2014/main" id="{AFD4BAF8-DDA7-EB06-1756-942703D9E5CC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40432" y="538864"/>
              <a:ext cx="0" cy="2988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8" name="グループ化 177">
            <a:extLst>
              <a:ext uri="{FF2B5EF4-FFF2-40B4-BE49-F238E27FC236}">
                <a16:creationId xmlns:a16="http://schemas.microsoft.com/office/drawing/2014/main" id="{BD31165B-5D96-CEEF-7B26-9F2AB0CFAEB0}"/>
              </a:ext>
            </a:extLst>
          </p:cNvPr>
          <p:cNvGrpSpPr/>
          <p:nvPr/>
        </p:nvGrpSpPr>
        <p:grpSpPr>
          <a:xfrm>
            <a:off x="2374011" y="1486298"/>
            <a:ext cx="306000" cy="360000"/>
            <a:chOff x="891107" y="717302"/>
            <a:chExt cx="298800" cy="627216"/>
          </a:xfrm>
        </p:grpSpPr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A201B716-E7E5-361D-F060-B842C4171EBF}"/>
                </a:ext>
              </a:extLst>
            </p:cNvPr>
            <p:cNvCxnSpPr>
              <a:cxnSpLocks/>
            </p:cNvCxnSpPr>
            <p:nvPr/>
          </p:nvCxnSpPr>
          <p:spPr>
            <a:xfrm>
              <a:off x="895352" y="717302"/>
              <a:ext cx="0" cy="62721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直線コネクタ 179">
              <a:extLst>
                <a:ext uri="{FF2B5EF4-FFF2-40B4-BE49-F238E27FC236}">
                  <a16:creationId xmlns:a16="http://schemas.microsoft.com/office/drawing/2014/main" id="{954975BD-5A46-7FF9-07B7-7469DA672487}"/>
                </a:ext>
              </a:extLst>
            </p:cNvPr>
            <p:cNvCxnSpPr>
              <a:cxnSpLocks/>
            </p:cNvCxnSpPr>
            <p:nvPr/>
          </p:nvCxnSpPr>
          <p:spPr>
            <a:xfrm>
              <a:off x="1188245" y="717302"/>
              <a:ext cx="0" cy="12544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直線コネクタ 180">
              <a:extLst>
                <a:ext uri="{FF2B5EF4-FFF2-40B4-BE49-F238E27FC236}">
                  <a16:creationId xmlns:a16="http://schemas.microsoft.com/office/drawing/2014/main" id="{70C45645-8A1A-4D0E-EC89-789918001C7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40507" y="572049"/>
              <a:ext cx="0" cy="2988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6" name="グループ化 185">
            <a:extLst>
              <a:ext uri="{FF2B5EF4-FFF2-40B4-BE49-F238E27FC236}">
                <a16:creationId xmlns:a16="http://schemas.microsoft.com/office/drawing/2014/main" id="{7C435726-BA92-38EB-33ED-7B62293C2276}"/>
              </a:ext>
            </a:extLst>
          </p:cNvPr>
          <p:cNvGrpSpPr/>
          <p:nvPr/>
        </p:nvGrpSpPr>
        <p:grpSpPr>
          <a:xfrm>
            <a:off x="2966895" y="1485497"/>
            <a:ext cx="306000" cy="360000"/>
            <a:chOff x="891107" y="717302"/>
            <a:chExt cx="298800" cy="627216"/>
          </a:xfrm>
        </p:grpSpPr>
        <p:cxnSp>
          <p:nvCxnSpPr>
            <p:cNvPr id="187" name="直線コネクタ 186">
              <a:extLst>
                <a:ext uri="{FF2B5EF4-FFF2-40B4-BE49-F238E27FC236}">
                  <a16:creationId xmlns:a16="http://schemas.microsoft.com/office/drawing/2014/main" id="{02F79EE0-9051-6276-AE77-0E40988A8751}"/>
                </a:ext>
              </a:extLst>
            </p:cNvPr>
            <p:cNvCxnSpPr>
              <a:cxnSpLocks/>
            </p:cNvCxnSpPr>
            <p:nvPr/>
          </p:nvCxnSpPr>
          <p:spPr>
            <a:xfrm>
              <a:off x="895352" y="717302"/>
              <a:ext cx="0" cy="62721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CFC279C1-AADE-56A2-F98C-036391D41FC2}"/>
                </a:ext>
              </a:extLst>
            </p:cNvPr>
            <p:cNvCxnSpPr>
              <a:cxnSpLocks/>
            </p:cNvCxnSpPr>
            <p:nvPr/>
          </p:nvCxnSpPr>
          <p:spPr>
            <a:xfrm>
              <a:off x="1188245" y="717302"/>
              <a:ext cx="0" cy="12544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直線コネクタ 188">
              <a:extLst>
                <a:ext uri="{FF2B5EF4-FFF2-40B4-BE49-F238E27FC236}">
                  <a16:creationId xmlns:a16="http://schemas.microsoft.com/office/drawing/2014/main" id="{EDF32AC1-926D-B8BB-97F1-06D268BFDC6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040507" y="572049"/>
              <a:ext cx="0" cy="2988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5A7D39D4-A44C-C18B-01C3-1B3D7F746612}"/>
              </a:ext>
            </a:extLst>
          </p:cNvPr>
          <p:cNvSpPr txBox="1"/>
          <p:nvPr/>
        </p:nvSpPr>
        <p:spPr>
          <a:xfrm>
            <a:off x="775845" y="61909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F6A7A688-65BA-A5E0-F5FC-202C9573C98F}"/>
              </a:ext>
            </a:extLst>
          </p:cNvPr>
          <p:cNvSpPr txBox="1"/>
          <p:nvPr/>
        </p:nvSpPr>
        <p:spPr>
          <a:xfrm>
            <a:off x="1398329" y="104944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8E083168-90E0-C40C-03D3-82CB72465B5B}"/>
              </a:ext>
            </a:extLst>
          </p:cNvPr>
          <p:cNvSpPr txBox="1"/>
          <p:nvPr/>
        </p:nvSpPr>
        <p:spPr>
          <a:xfrm>
            <a:off x="2397932" y="131321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C9E91994-43C1-7B95-7D00-9E1D5DB23178}"/>
              </a:ext>
            </a:extLst>
          </p:cNvPr>
          <p:cNvSpPr txBox="1"/>
          <p:nvPr/>
        </p:nvSpPr>
        <p:spPr>
          <a:xfrm>
            <a:off x="2986992" y="131321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31393C1-E024-6114-E4B6-4F4506A73F39}"/>
              </a:ext>
            </a:extLst>
          </p:cNvPr>
          <p:cNvSpPr txBox="1"/>
          <p:nvPr/>
        </p:nvSpPr>
        <p:spPr>
          <a:xfrm>
            <a:off x="23936" y="277976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図 17" descr="コンピューターの画面&#10;&#10;自動的に生成された説明">
            <a:extLst>
              <a:ext uri="{FF2B5EF4-FFF2-40B4-BE49-F238E27FC236}">
                <a16:creationId xmlns:a16="http://schemas.microsoft.com/office/drawing/2014/main" id="{F0AC048F-5CEE-7493-955A-4427E4006F5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753623" y="3864782"/>
            <a:ext cx="2171700" cy="529590"/>
          </a:xfrm>
          <a:prstGeom prst="rect">
            <a:avLst/>
          </a:prstGeom>
        </p:spPr>
      </p:pic>
      <p:pic>
        <p:nvPicPr>
          <p:cNvPr id="20" name="図 19" descr="暗い部屋の中に入っている&#10;&#10;中程度の精度で自動的に生成された説明">
            <a:extLst>
              <a:ext uri="{FF2B5EF4-FFF2-40B4-BE49-F238E27FC236}">
                <a16:creationId xmlns:a16="http://schemas.microsoft.com/office/drawing/2014/main" id="{018584B4-2A7C-DCE4-5F73-B0C15B0569C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103"/>
          <a:stretch/>
        </p:blipFill>
        <p:spPr>
          <a:xfrm rot="10800000">
            <a:off x="1372747" y="3213407"/>
            <a:ext cx="3552575" cy="566929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529A5B3-FD92-3B74-2C80-5BF34E4BBD90}"/>
              </a:ext>
            </a:extLst>
          </p:cNvPr>
          <p:cNvSpPr txBox="1"/>
          <p:nvPr/>
        </p:nvSpPr>
        <p:spPr>
          <a:xfrm>
            <a:off x="115888" y="3401963"/>
            <a:ext cx="1324402" cy="2149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altLang="ja-JP" sz="1200" b="0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iclev10029947m</a:t>
            </a:r>
            <a:endParaRPr lang="ja-JP" altLang="ja-JP" sz="12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9" name="グループ化 238">
            <a:extLst>
              <a:ext uri="{FF2B5EF4-FFF2-40B4-BE49-F238E27FC236}">
                <a16:creationId xmlns:a16="http://schemas.microsoft.com/office/drawing/2014/main" id="{090EDA14-FA9F-6765-47D5-F3E7FA733F2B}"/>
              </a:ext>
            </a:extLst>
          </p:cNvPr>
          <p:cNvGrpSpPr/>
          <p:nvPr/>
        </p:nvGrpSpPr>
        <p:grpSpPr>
          <a:xfrm>
            <a:off x="1500060" y="2870331"/>
            <a:ext cx="1140314" cy="381741"/>
            <a:chOff x="1500060" y="2870331"/>
            <a:chExt cx="1140314" cy="381741"/>
          </a:xfrm>
        </p:grpSpPr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D5945962-0704-0435-EC65-5B1F5856716B}"/>
                </a:ext>
              </a:extLst>
            </p:cNvPr>
            <p:cNvSpPr txBox="1"/>
            <p:nvPr/>
          </p:nvSpPr>
          <p:spPr>
            <a:xfrm>
              <a:off x="1500060" y="3005851"/>
              <a:ext cx="4988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14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75298DD3-8A04-2E3B-2DDB-676EB57ECE27}"/>
                </a:ext>
              </a:extLst>
            </p:cNvPr>
            <p:cNvSpPr txBox="1"/>
            <p:nvPr/>
          </p:nvSpPr>
          <p:spPr>
            <a:xfrm>
              <a:off x="1957174" y="3005851"/>
              <a:ext cx="6832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iranuhi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6226DB82-E8C4-54D2-7083-5B2C801260C0}"/>
                </a:ext>
              </a:extLst>
            </p:cNvPr>
            <p:cNvSpPr txBox="1"/>
            <p:nvPr/>
          </p:nvSpPr>
          <p:spPr>
            <a:xfrm>
              <a:off x="1573589" y="2870331"/>
              <a:ext cx="9669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mic DNA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E27551A2-4E19-99E3-A1E4-2380845854D3}"/>
                </a:ext>
              </a:extLst>
            </p:cNvPr>
            <p:cNvCxnSpPr>
              <a:cxnSpLocks/>
            </p:cNvCxnSpPr>
            <p:nvPr/>
          </p:nvCxnSpPr>
          <p:spPr>
            <a:xfrm>
              <a:off x="1597174" y="3056768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B35DF1F3-F7D2-C010-C83B-912BF8F03937}"/>
              </a:ext>
            </a:extLst>
          </p:cNvPr>
          <p:cNvSpPr txBox="1"/>
          <p:nvPr/>
        </p:nvSpPr>
        <p:spPr>
          <a:xfrm>
            <a:off x="2199625" y="4039831"/>
            <a:ext cx="596638" cy="2149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EF1a</a:t>
            </a:r>
            <a:endParaRPr lang="ja-JP" altLang="ja-JP" sz="1200" i="1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41FF2572-E604-4C18-A81D-951E9F7B5E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659100"/>
              </p:ext>
            </p:extLst>
          </p:nvPr>
        </p:nvGraphicFramePr>
        <p:xfrm>
          <a:off x="3558214" y="207440"/>
          <a:ext cx="1670400" cy="195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3DA5F8A2-A0A5-7FCE-6957-C62858A40B5B}"/>
              </a:ext>
            </a:extLst>
          </p:cNvPr>
          <p:cNvGrpSpPr/>
          <p:nvPr/>
        </p:nvGrpSpPr>
        <p:grpSpPr>
          <a:xfrm>
            <a:off x="3920801" y="2011892"/>
            <a:ext cx="1174640" cy="261610"/>
            <a:chOff x="3925034" y="1991787"/>
            <a:chExt cx="1174640" cy="261610"/>
          </a:xfrm>
        </p:grpSpPr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69A504F0-DA41-D615-0BEE-004A98E0F2DB}"/>
                </a:ext>
              </a:extLst>
            </p:cNvPr>
            <p:cNvSpPr txBox="1"/>
            <p:nvPr/>
          </p:nvSpPr>
          <p:spPr>
            <a:xfrm>
              <a:off x="3925034" y="1991787"/>
              <a:ext cx="5661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 DBF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07780167-EB47-798A-D97A-609DA5BA8AF0}"/>
                </a:ext>
              </a:extLst>
            </p:cNvPr>
            <p:cNvCxnSpPr/>
            <p:nvPr/>
          </p:nvCxnSpPr>
          <p:spPr>
            <a:xfrm>
              <a:off x="3956125" y="2035814"/>
              <a:ext cx="50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06824710-3093-7C57-C1E2-B91DE31A9E3D}"/>
                </a:ext>
              </a:extLst>
            </p:cNvPr>
            <p:cNvSpPr txBox="1"/>
            <p:nvPr/>
          </p:nvSpPr>
          <p:spPr>
            <a:xfrm>
              <a:off x="4533493" y="1991787"/>
              <a:ext cx="5661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DBF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81A48D4A-DBD3-1A0F-4451-BE595A6486B8}"/>
                </a:ext>
              </a:extLst>
            </p:cNvPr>
            <p:cNvCxnSpPr/>
            <p:nvPr/>
          </p:nvCxnSpPr>
          <p:spPr>
            <a:xfrm>
              <a:off x="4539500" y="2037438"/>
              <a:ext cx="50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AD036510-0580-4D4D-9E24-3E6F14B3272F}"/>
              </a:ext>
            </a:extLst>
          </p:cNvPr>
          <p:cNvSpPr txBox="1"/>
          <p:nvPr/>
        </p:nvSpPr>
        <p:spPr>
          <a:xfrm>
            <a:off x="4719852" y="1840264"/>
            <a:ext cx="380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D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FBA487CC-5843-950A-14F2-037099BBDABF}"/>
              </a:ext>
            </a:extLst>
          </p:cNvPr>
          <p:cNvSpPr txBox="1"/>
          <p:nvPr/>
        </p:nvSpPr>
        <p:spPr>
          <a:xfrm>
            <a:off x="4467926" y="1840264"/>
            <a:ext cx="380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D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EEC2A809-AFBC-475F-2450-711C3AE889A3}"/>
              </a:ext>
            </a:extLst>
          </p:cNvPr>
          <p:cNvSpPr txBox="1"/>
          <p:nvPr/>
        </p:nvSpPr>
        <p:spPr>
          <a:xfrm>
            <a:off x="4148923" y="1840264"/>
            <a:ext cx="380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D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テキスト ボックス 237">
            <a:extLst>
              <a:ext uri="{FF2B5EF4-FFF2-40B4-BE49-F238E27FC236}">
                <a16:creationId xmlns:a16="http://schemas.microsoft.com/office/drawing/2014/main" id="{85E13D63-ED7A-77FD-FB8B-898796319418}"/>
              </a:ext>
            </a:extLst>
          </p:cNvPr>
          <p:cNvSpPr txBox="1"/>
          <p:nvPr/>
        </p:nvSpPr>
        <p:spPr>
          <a:xfrm>
            <a:off x="3877034" y="1840264"/>
            <a:ext cx="380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D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0" name="グループ化 239">
            <a:extLst>
              <a:ext uri="{FF2B5EF4-FFF2-40B4-BE49-F238E27FC236}">
                <a16:creationId xmlns:a16="http://schemas.microsoft.com/office/drawing/2014/main" id="{F4D3294F-562A-2F5D-963A-932619F141F8}"/>
              </a:ext>
            </a:extLst>
          </p:cNvPr>
          <p:cNvGrpSpPr/>
          <p:nvPr/>
        </p:nvGrpSpPr>
        <p:grpSpPr>
          <a:xfrm>
            <a:off x="2780704" y="2870331"/>
            <a:ext cx="1140314" cy="381741"/>
            <a:chOff x="1500060" y="2870331"/>
            <a:chExt cx="1140314" cy="381741"/>
          </a:xfrm>
        </p:grpSpPr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DB9A791C-CD7C-AAD5-2C36-5680572061DC}"/>
                </a:ext>
              </a:extLst>
            </p:cNvPr>
            <p:cNvSpPr txBox="1"/>
            <p:nvPr/>
          </p:nvSpPr>
          <p:spPr>
            <a:xfrm>
              <a:off x="1500060" y="3005851"/>
              <a:ext cx="4988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14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570E095E-1C85-D07D-BDA8-E7CC0C986940}"/>
                </a:ext>
              </a:extLst>
            </p:cNvPr>
            <p:cNvSpPr txBox="1"/>
            <p:nvPr/>
          </p:nvSpPr>
          <p:spPr>
            <a:xfrm>
              <a:off x="1957174" y="3005851"/>
              <a:ext cx="6832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iranuhi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テキスト ボックス 244">
              <a:extLst>
                <a:ext uri="{FF2B5EF4-FFF2-40B4-BE49-F238E27FC236}">
                  <a16:creationId xmlns:a16="http://schemas.microsoft.com/office/drawing/2014/main" id="{2A20D332-F0E5-70BF-C666-FEE801DFC13A}"/>
                </a:ext>
              </a:extLst>
            </p:cNvPr>
            <p:cNvSpPr txBox="1"/>
            <p:nvPr/>
          </p:nvSpPr>
          <p:spPr>
            <a:xfrm>
              <a:off x="1759336" y="2870331"/>
              <a:ext cx="5293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 DBF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6" name="直線コネクタ 245">
              <a:extLst>
                <a:ext uri="{FF2B5EF4-FFF2-40B4-BE49-F238E27FC236}">
                  <a16:creationId xmlns:a16="http://schemas.microsoft.com/office/drawing/2014/main" id="{D09C1BE5-4EBB-D44D-DEB2-9BAA031D6775}"/>
                </a:ext>
              </a:extLst>
            </p:cNvPr>
            <p:cNvCxnSpPr>
              <a:cxnSpLocks/>
            </p:cNvCxnSpPr>
            <p:nvPr/>
          </p:nvCxnSpPr>
          <p:spPr>
            <a:xfrm>
              <a:off x="1597174" y="3056768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0" name="グループ化 249">
            <a:extLst>
              <a:ext uri="{FF2B5EF4-FFF2-40B4-BE49-F238E27FC236}">
                <a16:creationId xmlns:a16="http://schemas.microsoft.com/office/drawing/2014/main" id="{91C67229-D48F-FDA0-1D7B-6574DE8AC2EF}"/>
              </a:ext>
            </a:extLst>
          </p:cNvPr>
          <p:cNvGrpSpPr/>
          <p:nvPr/>
        </p:nvGrpSpPr>
        <p:grpSpPr>
          <a:xfrm>
            <a:off x="3867812" y="2870331"/>
            <a:ext cx="1140314" cy="381741"/>
            <a:chOff x="1500060" y="2870331"/>
            <a:chExt cx="1140314" cy="381741"/>
          </a:xfrm>
        </p:grpSpPr>
        <p:sp>
          <p:nvSpPr>
            <p:cNvPr id="251" name="テキスト ボックス 250">
              <a:extLst>
                <a:ext uri="{FF2B5EF4-FFF2-40B4-BE49-F238E27FC236}">
                  <a16:creationId xmlns:a16="http://schemas.microsoft.com/office/drawing/2014/main" id="{AF12D024-A5C4-1EEA-F0DF-A798D37A74A3}"/>
                </a:ext>
              </a:extLst>
            </p:cNvPr>
            <p:cNvSpPr txBox="1"/>
            <p:nvPr/>
          </p:nvSpPr>
          <p:spPr>
            <a:xfrm>
              <a:off x="1500060" y="3005851"/>
              <a:ext cx="4988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14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id="{EBC9BFC5-B367-72E9-4455-5DF7A1F7B424}"/>
                </a:ext>
              </a:extLst>
            </p:cNvPr>
            <p:cNvSpPr txBox="1"/>
            <p:nvPr/>
          </p:nvSpPr>
          <p:spPr>
            <a:xfrm>
              <a:off x="1957174" y="3005851"/>
              <a:ext cx="6832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iranuhi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テキスト ボックス 252">
              <a:extLst>
                <a:ext uri="{FF2B5EF4-FFF2-40B4-BE49-F238E27FC236}">
                  <a16:creationId xmlns:a16="http://schemas.microsoft.com/office/drawing/2014/main" id="{B04B8AAB-7FE3-41E4-20FB-BA67125B35E6}"/>
                </a:ext>
              </a:extLst>
            </p:cNvPr>
            <p:cNvSpPr txBox="1"/>
            <p:nvPr/>
          </p:nvSpPr>
          <p:spPr>
            <a:xfrm>
              <a:off x="1759336" y="2870331"/>
              <a:ext cx="5293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DBF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4" name="直線コネクタ 253">
              <a:extLst>
                <a:ext uri="{FF2B5EF4-FFF2-40B4-BE49-F238E27FC236}">
                  <a16:creationId xmlns:a16="http://schemas.microsoft.com/office/drawing/2014/main" id="{DDCE6C4B-ACA0-D42B-7F3F-F3732766C1B9}"/>
                </a:ext>
              </a:extLst>
            </p:cNvPr>
            <p:cNvCxnSpPr>
              <a:cxnSpLocks/>
            </p:cNvCxnSpPr>
            <p:nvPr/>
          </p:nvCxnSpPr>
          <p:spPr>
            <a:xfrm>
              <a:off x="1597174" y="3056768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859125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6</TotalTime>
  <Words>239</Words>
  <Application>Microsoft Office PowerPoint</Application>
  <PresentationFormat>画面に合わせる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go Goto</dc:creator>
  <cp:lastModifiedBy>Shingo Goto</cp:lastModifiedBy>
  <cp:revision>41</cp:revision>
  <cp:lastPrinted>2023-04-14T15:28:48Z</cp:lastPrinted>
  <dcterms:created xsi:type="dcterms:W3CDTF">2023-04-14T14:24:15Z</dcterms:created>
  <dcterms:modified xsi:type="dcterms:W3CDTF">2023-05-08T07:45:57Z</dcterms:modified>
</cp:coreProperties>
</file>